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6858000" cy="9906000" type="A4"/>
  <p:notesSz cx="6669088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ndre Lopes" initials="AL" lastIdx="15" clrIdx="0">
    <p:extLst/>
  </p:cmAuthor>
  <p:cmAuthor id="2" name="Alison Backen" initials="AB" lastIdx="0" clrIdx="1"/>
  <p:cmAuthor id="3" name="McNamara Mairead (RBV) NHS Christie Tr" initials="MM(NCT" lastIdx="5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6600"/>
    <a:srgbClr val="A0A0A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36571" autoAdjust="0"/>
  </p:normalViewPr>
  <p:slideViewPr>
    <p:cSldViewPr snapToGrid="0">
      <p:cViewPr varScale="1">
        <p:scale>
          <a:sx n="81" d="100"/>
          <a:sy n="81" d="100"/>
        </p:scale>
        <p:origin x="-3978" y="-9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25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778250" y="0"/>
            <a:ext cx="288925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888E15E-F8B3-4F53-9E76-E902B32B34C4}" type="datetimeFigureOut">
              <a:rPr lang="en-GB" smtClean="0"/>
              <a:t>04/06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46288" y="744538"/>
            <a:ext cx="2576512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66750" y="4714875"/>
            <a:ext cx="5335588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88925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778250" y="9428163"/>
            <a:ext cx="288925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A09F8C5-D569-417B-97F3-C54109F2A7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57857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09F8C5-D569-417B-97F3-C54109F2A7FC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48792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848C-25E1-4123-914C-122A41EAF410}" type="datetimeFigureOut">
              <a:rPr lang="en-GB" smtClean="0"/>
              <a:t>04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CD350-A6D6-4936-B146-D3E77D1093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89636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848C-25E1-4123-914C-122A41EAF410}" type="datetimeFigureOut">
              <a:rPr lang="en-GB" smtClean="0"/>
              <a:t>04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CD350-A6D6-4936-B146-D3E77D1093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8353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29697"/>
            <a:ext cx="3357563" cy="112680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848C-25E1-4123-914C-122A41EAF410}" type="datetimeFigureOut">
              <a:rPr lang="en-GB" smtClean="0"/>
              <a:t>04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CD350-A6D6-4936-B146-D3E77D1093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4419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848C-25E1-4123-914C-122A41EAF410}" type="datetimeFigureOut">
              <a:rPr lang="en-GB" smtClean="0"/>
              <a:t>04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CD350-A6D6-4936-B146-D3E77D1093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88889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848C-25E1-4123-914C-122A41EAF410}" type="datetimeFigureOut">
              <a:rPr lang="en-GB" smtClean="0"/>
              <a:t>04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CD350-A6D6-4936-B146-D3E77D1093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77520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848C-25E1-4123-914C-122A41EAF410}" type="datetimeFigureOut">
              <a:rPr lang="en-GB" smtClean="0"/>
              <a:t>04/06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CD350-A6D6-4936-B146-D3E77D1093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92024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848C-25E1-4123-914C-122A41EAF410}" type="datetimeFigureOut">
              <a:rPr lang="en-GB" smtClean="0"/>
              <a:t>04/06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CD350-A6D6-4936-B146-D3E77D1093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06042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848C-25E1-4123-914C-122A41EAF410}" type="datetimeFigureOut">
              <a:rPr lang="en-GB" smtClean="0"/>
              <a:t>04/06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CD350-A6D6-4936-B146-D3E77D1093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80136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848C-25E1-4123-914C-122A41EAF410}" type="datetimeFigureOut">
              <a:rPr lang="en-GB" smtClean="0"/>
              <a:t>04/06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CD350-A6D6-4936-B146-D3E77D1093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40920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848C-25E1-4123-914C-122A41EAF410}" type="datetimeFigureOut">
              <a:rPr lang="en-GB" smtClean="0"/>
              <a:t>04/06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CD350-A6D6-4936-B146-D3E77D1093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60087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80848C-25E1-4123-914C-122A41EAF410}" type="datetimeFigureOut">
              <a:rPr lang="en-GB" smtClean="0"/>
              <a:t>04/06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CD350-A6D6-4936-B146-D3E77D1093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08495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80848C-25E1-4123-914C-122A41EAF410}" type="datetimeFigureOut">
              <a:rPr lang="en-GB" smtClean="0"/>
              <a:t>04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3CD350-A6D6-4936-B146-D3E77D1093D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487202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1233443" y="6526286"/>
            <a:ext cx="455039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b="1" dirty="0"/>
              <a:t>Supplementary Figure </a:t>
            </a:r>
            <a:r>
              <a:rPr lang="en-GB" sz="1000" b="1" dirty="0" smtClean="0"/>
              <a:t>3. Median and range of baseline circulating biomarkers.</a:t>
            </a:r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7000609"/>
              </p:ext>
            </p:extLst>
          </p:nvPr>
        </p:nvGraphicFramePr>
        <p:xfrm>
          <a:off x="1332000" y="1394460"/>
          <a:ext cx="4194000" cy="4104000"/>
        </p:xfrm>
        <a:graphic>
          <a:graphicData uri="http://schemas.openxmlformats.org/drawingml/2006/table">
            <a:tbl>
              <a:tblPr firstRow="1" firstCol="1" bandRow="1"/>
              <a:tblGrid>
                <a:gridCol w="1188000"/>
                <a:gridCol w="315000"/>
                <a:gridCol w="1188000"/>
                <a:gridCol w="315000"/>
                <a:gridCol w="1188000"/>
              </a:tblGrid>
              <a:tr h="2160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 smtClean="0">
                          <a:effectLst/>
                          <a:latin typeface="+mn-lt"/>
                          <a:ea typeface="Calibri"/>
                          <a:cs typeface="Times New Roman"/>
                        </a:rPr>
                        <a:t>Placebo</a:t>
                      </a:r>
                      <a:endParaRPr lang="en-GB" sz="1000" b="1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2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 smtClean="0">
                          <a:effectLst/>
                          <a:latin typeface="+mn-lt"/>
                          <a:ea typeface="Calibri"/>
                          <a:cs typeface="Times New Roman"/>
                        </a:rPr>
                        <a:t>Cediranib</a:t>
                      </a:r>
                      <a:endParaRPr lang="en-GB" sz="1000" b="1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2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Baseline biomarker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 smtClean="0">
                          <a:effectLst/>
                          <a:latin typeface="+mn-lt"/>
                          <a:ea typeface="Calibri"/>
                          <a:cs typeface="Times New Roman"/>
                        </a:rPr>
                        <a:t>N</a:t>
                      </a:r>
                      <a:endParaRPr lang="en-GB" sz="1000" b="1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0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Calibri"/>
                          <a:cs typeface="Times New Roman"/>
                        </a:rPr>
                        <a:t>Median</a:t>
                      </a:r>
                      <a:r>
                        <a:rPr kumimoji="0" lang="en-GB" sz="10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Calibri"/>
                          <a:cs typeface="Times New Roman"/>
                        </a:rPr>
                        <a:t> (range)</a:t>
                      </a:r>
                      <a:endParaRPr kumimoji="0" lang="en-GB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N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 smtClean="0">
                          <a:effectLst/>
                          <a:latin typeface="+mn-lt"/>
                          <a:ea typeface="Calibri"/>
                          <a:cs typeface="Times New Roman"/>
                        </a:rPr>
                        <a:t>Median</a:t>
                      </a:r>
                      <a:r>
                        <a:rPr lang="en-GB" sz="1000" dirty="0" smtClean="0">
                          <a:effectLst/>
                          <a:latin typeface="+mn-lt"/>
                          <a:ea typeface="Calibri"/>
                          <a:cs typeface="Times New Roman"/>
                        </a:rPr>
                        <a:t> (range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Ang1 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(pg/ml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58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 1269 (72 - 9248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59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1492 (196 - 77673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Ang2 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(pg/ml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58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607 (43 - 8177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59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590 (118 - 16221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CK18 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(U/L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60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715 (157 - 3004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59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744 (222 - 3305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FGFb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 (pg/ml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58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159 (1 - 3882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59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167 (1 - 7065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HGF 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(pg/ml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58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286 (86 - 6766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59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307 (61 - 3797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IL6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 (pg/ml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58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21 (3·8 - 768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59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50 (3·4 - 419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IL8 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(pg/ml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58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35 (0·2 - 476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59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51 (0·2 - 444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KGF 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(pg/ml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58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11 (0·5 - 564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59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12 (1·8 - 220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PDGFbb </a:t>
                      </a:r>
                      <a:r>
                        <a:rPr lang="en-GB" sz="1000" dirty="0"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(pg/ml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58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152 (0·6 - 648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59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172 (5·6 - 769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PlGF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 (pg/ml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58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29 (1·4 - 3818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59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32 (2·8 - 1312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SDF1b 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(pg/ml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58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1998 (505 - 4410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59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1743 (669 - 3352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Tie2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 (pg/ml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58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7283 (2446 - 16313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59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7552 (929 - 22961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VEGF A 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(pg/ml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58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151 (2·5 - 1330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59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171 (33·5 - 845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VEGF C 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(pg/ml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58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122 (7·0 - 2481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59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153 (7·8 - 2168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VEGFR1 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(pg/ml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58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73 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(27 - 3118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59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73 (24 - 1145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VEGFR2 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(pg/ml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58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6236 (2462 - 12180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59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6459 (2664 - 18559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6000">
                <a:tc>
                  <a:txBody>
                    <a:bodyPr/>
                    <a:lstStyle/>
                    <a:p>
                      <a:pPr algn="just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CTC count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 (in </a:t>
                      </a: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7.5ml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49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0 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(0 - 15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46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1 </a:t>
                      </a: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/>
                          <a:cs typeface="Times New Roman"/>
                        </a:rPr>
                        <a:t>(0 - 44)</a:t>
                      </a:r>
                      <a:endParaRPr lang="en-GB" sz="1000" dirty="0">
                        <a:effectLst/>
                        <a:latin typeface="+mn-lt"/>
                        <a:ea typeface="Calibri"/>
                        <a:cs typeface="Times New Roman"/>
                      </a:endParaRPr>
                    </a:p>
                  </a:txBody>
                  <a:tcPr marL="44084" marR="440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6858761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28</TotalTime>
  <Words>338</Words>
  <Application>Microsoft Office PowerPoint</Application>
  <PresentationFormat>A4 Paper (210x297 mm)</PresentationFormat>
  <Paragraphs>9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Manches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ison Backen</dc:creator>
  <cp:lastModifiedBy>Alison Backen</cp:lastModifiedBy>
  <cp:revision>236</cp:revision>
  <cp:lastPrinted>2016-06-08T12:53:26Z</cp:lastPrinted>
  <dcterms:created xsi:type="dcterms:W3CDTF">2016-01-22T08:55:16Z</dcterms:created>
  <dcterms:modified xsi:type="dcterms:W3CDTF">2018-06-04T07:51:23Z</dcterms:modified>
</cp:coreProperties>
</file>